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19" autoAdjust="0"/>
  </p:normalViewPr>
  <p:slideViewPr>
    <p:cSldViewPr>
      <p:cViewPr>
        <p:scale>
          <a:sx n="70" d="100"/>
          <a:sy n="70" d="100"/>
        </p:scale>
        <p:origin x="-1716" y="-2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C127A-65D9-4257-AB54-BFF2575DCB07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BD48EF-94A9-49AB-8904-D956D12BAD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989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CA2C36-B6DE-4864-9339-FADEE753FB8F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Relationship Id="rId9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>
            <a:grpSpLocks noChangeAspect="1"/>
          </p:cNvGrpSpPr>
          <p:nvPr/>
        </p:nvGrpSpPr>
        <p:grpSpPr>
          <a:xfrm>
            <a:off x="405360" y="912367"/>
            <a:ext cx="6264000" cy="4224843"/>
            <a:chOff x="548680" y="251520"/>
            <a:chExt cx="4968552" cy="3351110"/>
          </a:xfrm>
        </p:grpSpPr>
        <p:pic>
          <p:nvPicPr>
            <p:cNvPr id="77826" name="Picture 2" descr="C:\Documents and Settings\mobs4ah2\My Documents\PhD\Thesis\for thesis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48680" y="251520"/>
              <a:ext cx="2418505" cy="16345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77827" name="Picture 3" descr="C:\Documents and Settings\mobs4ah2\My Documents\PhD\Thesis\LXR a neg chamber 1 for thesis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48680" y="1968035"/>
              <a:ext cx="2418505" cy="16345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77829" name="Picture 5" descr="C:\Documents and Settings\mobs4ah2\My Documents\PhD\Thesis\LXR B neg chamber 5 for thesis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098727" y="1968035"/>
              <a:ext cx="2418505" cy="16345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77830" name="Picture 6" descr="C:\Documents and Settings\mobs4ah2\My Documents\PhD\Thesis\LXR B chamber 8 for thesis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098727" y="251520"/>
              <a:ext cx="2418505" cy="16345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548680" y="251520"/>
              <a:ext cx="475460" cy="279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A)</a:t>
              </a:r>
              <a:endParaRPr lang="en-GB" sz="10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098727" y="251520"/>
              <a:ext cx="475460" cy="279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B)</a:t>
              </a:r>
              <a:endParaRPr lang="en-GB" sz="10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48680" y="1968035"/>
              <a:ext cx="475460" cy="279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C)</a:t>
              </a:r>
              <a:endParaRPr lang="en-GB" sz="10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098727" y="1968035"/>
              <a:ext cx="475460" cy="279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D)</a:t>
              </a:r>
              <a:endParaRPr lang="en-GB" sz="1000" b="1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1412776" y="5232847"/>
            <a:ext cx="475460" cy="2794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(E)</a:t>
            </a:r>
            <a:endParaRPr lang="en-GB" sz="1000" b="1" dirty="0"/>
          </a:p>
        </p:txBody>
      </p:sp>
      <p:graphicFrame>
        <p:nvGraphicFramePr>
          <p:cNvPr id="29699" name="Object 3"/>
          <p:cNvGraphicFramePr>
            <a:graphicFrameLocks noChangeAspect="1"/>
          </p:cNvGraphicFramePr>
          <p:nvPr/>
        </p:nvGraphicFramePr>
        <p:xfrm>
          <a:off x="1470209" y="5232847"/>
          <a:ext cx="4407063" cy="22288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07" name="Prism 5" r:id="rId8" imgW="4924080" imgH="2774880" progId="Prism5.Document">
                  <p:embed/>
                </p:oleObj>
              </mc:Choice>
              <mc:Fallback>
                <p:oleObj name="Prism 5" r:id="rId8" imgW="4924080" imgH="2774880" progId="Prism5.Document">
                  <p:embed/>
                  <p:pic>
                    <p:nvPicPr>
                      <p:cNvPr id="0" name="Picture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70209" y="5232847"/>
                        <a:ext cx="4407063" cy="22288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Rectangle 3"/>
          <p:cNvSpPr>
            <a:spLocks noChangeAspect="1" noChangeArrowheads="1"/>
          </p:cNvSpPr>
          <p:nvPr/>
        </p:nvSpPr>
        <p:spPr bwMode="auto">
          <a:xfrm>
            <a:off x="0" y="386244"/>
            <a:ext cx="6228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GB" b="1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Additional File </a:t>
            </a:r>
            <a:r>
              <a:rPr lang="en-GB" b="1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10</a:t>
            </a:r>
            <a:endParaRPr kumimoji="0" lang="en-GB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9707" name="Rectangle 11"/>
          <p:cNvSpPr>
            <a:spLocks noChangeArrowheads="1"/>
          </p:cNvSpPr>
          <p:nvPr/>
        </p:nvSpPr>
        <p:spPr bwMode="auto">
          <a:xfrm>
            <a:off x="0" y="7579493"/>
            <a:ext cx="6858000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The effect of GW3965 on the production of CXCL10 from poly I:C stimulated BEAS-2Bs.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Immunocytochemical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staining confirmed the presence of LXR</a:t>
            </a:r>
            <a:r>
              <a:rPr kumimoji="0" lang="el-G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α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(A) and LXR</a:t>
            </a:r>
            <a:r>
              <a:rPr kumimoji="0" lang="el-G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β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(B) in BEAS-2Bs. Omission of the primary antibodies displayed no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immunoreactivity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for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LXRα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(C) and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LXRβ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(D).  (E) BEAS-2Bs (n=3) were pre-treated with vehicle (DMSO 0.05%) (white bars), GW3965 (1 µM or 10 µM) (light grey bars), or dexamethasone (1 µM) (dark grey bars) for 1 h prior to stimulation with poly I:C (10 µg/ml) for 24 h.  Culture supernatants were analysed for CXCL10.  Data shown are mean ± SEM where * = significant reduction of CXCL10 below vehicle control (p&lt;0.05)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</TotalTime>
  <Words>158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imon Lea</dc:creator>
  <cp:lastModifiedBy>Andrew Higham</cp:lastModifiedBy>
  <cp:revision>43</cp:revision>
  <dcterms:created xsi:type="dcterms:W3CDTF">2012-05-28T12:09:01Z</dcterms:created>
  <dcterms:modified xsi:type="dcterms:W3CDTF">2013-09-02T13:13:30Z</dcterms:modified>
</cp:coreProperties>
</file>